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8CF6B3-A20B-4009-9D70-5E6E6CCF89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F9E9C0-05DA-486D-9033-0BFB8801DC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284AFD-6A0C-4549-B2AA-426F280C8B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0E9970-669E-46C1-B487-5D541ED767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9358F0-72FB-4E26-A14B-B6A342E70D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B04B3B-D9AC-4679-A35F-0DE15AAFB1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1E2173-1F0A-48BC-BF18-9B25235AB9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A489A2-F952-4029-A2FC-7EED70BE7F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83A659-1457-4F48-8727-AC2E5533B9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2E2BD8-A937-43F6-A28F-8D7306B7E4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1347F1-F346-4036-A2FB-120872BB3C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22DB57-53C3-4B46-B42A-088DD915A0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545AD62-41BA-4D06-BE37-8F7EA81E2B7C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841480" y="6334200"/>
            <a:ext cx="1288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2897280" y="622764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 flipH="1">
            <a:off x="3336480" y="385920"/>
            <a:ext cx="111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3497760" y="316080"/>
            <a:ext cx="1180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haetomium globosu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 flipH="1">
            <a:off x="3336480" y="555480"/>
            <a:ext cx="795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3471120" y="492120"/>
            <a:ext cx="973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Neurospora crassa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 flipH="1">
            <a:off x="3309480" y="469800"/>
            <a:ext cx="27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3336840" y="385920"/>
            <a:ext cx="1800" cy="169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3216600" y="3492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8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 flipH="1">
            <a:off x="3309840" y="727200"/>
            <a:ext cx="1238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3485160" y="663480"/>
            <a:ext cx="1186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Fusarium graminearu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 flipH="1">
            <a:off x="3255840" y="598320"/>
            <a:ext cx="54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3309840" y="469800"/>
            <a:ext cx="1800" cy="257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3189600" y="4777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 flipH="1">
            <a:off x="3255840" y="903240"/>
            <a:ext cx="1065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3417480" y="839880"/>
            <a:ext cx="1023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Magnaporthe grisea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 flipH="1">
            <a:off x="3184560" y="747720"/>
            <a:ext cx="712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3255840" y="598320"/>
            <a:ext cx="1800" cy="30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3140280" y="6332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8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 flipH="1">
            <a:off x="3242880" y="1074600"/>
            <a:ext cx="176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3310200" y="1009800"/>
            <a:ext cx="11970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Sclerotinia sclerotioru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 flipH="1">
            <a:off x="3242880" y="1251000"/>
            <a:ext cx="3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3301560" y="1187280"/>
            <a:ext cx="794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Botritys cinerea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 flipH="1">
            <a:off x="3184200" y="1165320"/>
            <a:ext cx="586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3243240" y="1074600"/>
            <a:ext cx="1440" cy="176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3037320" y="10638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 flipH="1">
            <a:off x="3154320" y="957240"/>
            <a:ext cx="30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3184560" y="747720"/>
            <a:ext cx="1440" cy="417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3064320" y="8366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 flipH="1">
            <a:off x="3260880" y="1422360"/>
            <a:ext cx="568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3373920" y="1357200"/>
            <a:ext cx="7610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Asp. fumigatu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 flipH="1">
            <a:off x="3260880" y="1598760"/>
            <a:ext cx="54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3363840" y="1533600"/>
            <a:ext cx="692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Asp. nidulan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 flipH="1">
            <a:off x="3176640" y="1512720"/>
            <a:ext cx="84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3260880" y="1422360"/>
            <a:ext cx="1440" cy="176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3048840" y="140184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 flipH="1">
            <a:off x="3176280" y="1770120"/>
            <a:ext cx="745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3305880" y="1704960"/>
            <a:ext cx="1043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occidioides immiti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 flipH="1">
            <a:off x="3154320" y="1641600"/>
            <a:ext cx="223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3176640" y="1512720"/>
            <a:ext cx="1440" cy="257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3062520" y="16207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 flipH="1">
            <a:off x="3063600" y="1298520"/>
            <a:ext cx="903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3154320" y="957240"/>
            <a:ext cx="1800" cy="684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3034080" y="11779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 flipH="1">
            <a:off x="3063600" y="1946160"/>
            <a:ext cx="2588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3377520" y="1881360"/>
            <a:ext cx="1201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Stagonospora nodoru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 flipH="1">
            <a:off x="2957400" y="1619280"/>
            <a:ext cx="1065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3063960" y="1298520"/>
            <a:ext cx="1440" cy="647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2948400" y="15048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3322800" y="2116080"/>
            <a:ext cx="1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3376440" y="2052720"/>
            <a:ext cx="16297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ry. neoformans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var. </a:t>
            </a: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grubii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99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 flipH="1">
            <a:off x="3322800" y="2293920"/>
            <a:ext cx="93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3378600" y="2224080"/>
            <a:ext cx="20887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ry. neoformans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var. </a:t>
            </a: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neoformans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JEC2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 flipH="1">
            <a:off x="3157200" y="2201760"/>
            <a:ext cx="165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3322800" y="2116080"/>
            <a:ext cx="1440" cy="177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3124800" y="208764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 flipH="1">
            <a:off x="3157200" y="2463840"/>
            <a:ext cx="2682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3475080" y="2400480"/>
            <a:ext cx="812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Ustilago maydi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 flipH="1">
            <a:off x="3082680" y="2336760"/>
            <a:ext cx="745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3157560" y="2201760"/>
            <a:ext cx="1440" cy="262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3019680" y="22240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8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 flipH="1">
            <a:off x="3144600" y="263988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3265920" y="2571840"/>
            <a:ext cx="1018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oprinopsis cinerea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 flipH="1">
            <a:off x="3144960" y="2811600"/>
            <a:ext cx="1252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3316680" y="2747880"/>
            <a:ext cx="1561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Phanerochaete chrysosporium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 flipH="1">
            <a:off x="3083040" y="2725560"/>
            <a:ext cx="619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3144960" y="2639880"/>
            <a:ext cx="1440" cy="171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3029400" y="27115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 flipH="1">
            <a:off x="3018960" y="2529000"/>
            <a:ext cx="637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3083040" y="2336760"/>
            <a:ext cx="1440" cy="38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2967480" y="24163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 flipH="1">
            <a:off x="3019320" y="2987640"/>
            <a:ext cx="2145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3283920" y="2919240"/>
            <a:ext cx="858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Rhizopus oryza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 flipH="1">
            <a:off x="2957400" y="2759040"/>
            <a:ext cx="619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3019320" y="2529000"/>
            <a:ext cx="1800" cy="458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2886480" y="27432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 flipH="1">
            <a:off x="2935080" y="2192400"/>
            <a:ext cx="21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2957400" y="1619280"/>
            <a:ext cx="1800" cy="1139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2833920" y="20829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 flipH="1">
            <a:off x="2935440" y="3159000"/>
            <a:ext cx="2491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3237480" y="3095640"/>
            <a:ext cx="1561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Schizosaccharomyces pombe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 flipH="1">
            <a:off x="2841120" y="2673360"/>
            <a:ext cx="93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2935440" y="2192400"/>
            <a:ext cx="1440" cy="966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2819880" y="25574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3840120" y="3335400"/>
            <a:ext cx="1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3887280" y="3265560"/>
            <a:ext cx="11408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Sac. cerevisiae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S288c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3840120" y="3506760"/>
            <a:ext cx="1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3888000" y="3443400"/>
            <a:ext cx="1285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Sac. cerevisiae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RM11-1a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 flipH="1">
            <a:off x="3835080" y="3421080"/>
            <a:ext cx="46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3840120" y="3335400"/>
            <a:ext cx="1800" cy="171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3658320" y="330984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 flipH="1">
            <a:off x="3835440" y="3683160"/>
            <a:ext cx="316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3916080" y="3613320"/>
            <a:ext cx="8010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Sac. paradoxu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 flipH="1">
            <a:off x="3795840" y="3549600"/>
            <a:ext cx="39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3835440" y="3421080"/>
            <a:ext cx="1440" cy="262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3708720" y="34434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 flipH="1">
            <a:off x="3795840" y="3854520"/>
            <a:ext cx="172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3865680" y="3789360"/>
            <a:ext cx="8665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Sac. kudriavzevii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 flipH="1">
            <a:off x="3785760" y="3705120"/>
            <a:ext cx="97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3795840" y="3549600"/>
            <a:ext cx="1440" cy="30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3669120" y="35942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 flipH="1">
            <a:off x="3916080" y="4030560"/>
            <a:ext cx="2984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4268880" y="3960720"/>
            <a:ext cx="698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Sac. bayanu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 flipH="1">
            <a:off x="3916440" y="4202280"/>
            <a:ext cx="8287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>
            <a:off x="4799880" y="4137120"/>
            <a:ext cx="66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Sac. mikata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 flipH="1">
            <a:off x="3786120" y="4116240"/>
            <a:ext cx="1303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3916440" y="4030560"/>
            <a:ext cx="1440" cy="171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3785040" y="40053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9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 flipH="1">
            <a:off x="3657240" y="3908520"/>
            <a:ext cx="1285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3786120" y="3705120"/>
            <a:ext cx="1800" cy="411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3654720" y="38019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 flipH="1">
            <a:off x="3657600" y="4378320"/>
            <a:ext cx="15955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5306760" y="4308480"/>
            <a:ext cx="642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Sac. castellii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 flipH="1">
            <a:off x="3564000" y="4143240"/>
            <a:ext cx="93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3657600" y="3908520"/>
            <a:ext cx="1440" cy="469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3526200" y="40323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9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 flipH="1">
            <a:off x="3564000" y="4549680"/>
            <a:ext cx="1872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>
            <a:off x="3805200" y="4484520"/>
            <a:ext cx="654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Sac.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kluyveri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"/>
          <p:cNvSpPr/>
          <p:nvPr/>
        </p:nvSpPr>
        <p:spPr>
          <a:xfrm flipH="1">
            <a:off x="3448080" y="4346640"/>
            <a:ext cx="115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>
            <a:off x="3564000" y="4143240"/>
            <a:ext cx="1440" cy="406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>
            <a:off x="3432600" y="42354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9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 flipH="1">
            <a:off x="3448080" y="4726080"/>
            <a:ext cx="480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>
            <a:off x="3983760" y="4656240"/>
            <a:ext cx="6912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an. glabrata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 flipH="1">
            <a:off x="3398400" y="4532400"/>
            <a:ext cx="493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>
            <a:off x="3448080" y="4346640"/>
            <a:ext cx="1440" cy="379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>
            <a:off x="3316680" y="44276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 flipH="1">
            <a:off x="3519360" y="4896000"/>
            <a:ext cx="3384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"/>
          <p:cNvSpPr/>
          <p:nvPr/>
        </p:nvSpPr>
        <p:spPr>
          <a:xfrm>
            <a:off x="3906720" y="4832280"/>
            <a:ext cx="1076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Kluyveromyces lacti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"/>
          <p:cNvSpPr/>
          <p:nvPr/>
        </p:nvSpPr>
        <p:spPr>
          <a:xfrm flipH="1">
            <a:off x="3519000" y="5073480"/>
            <a:ext cx="2494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>
            <a:off x="3819240" y="5003640"/>
            <a:ext cx="680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Ash. gossypii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"/>
          <p:cNvSpPr/>
          <p:nvPr/>
        </p:nvSpPr>
        <p:spPr>
          <a:xfrm flipH="1">
            <a:off x="3398400" y="4981680"/>
            <a:ext cx="120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"/>
          <p:cNvSpPr/>
          <p:nvPr/>
        </p:nvSpPr>
        <p:spPr>
          <a:xfrm>
            <a:off x="3519360" y="4896000"/>
            <a:ext cx="1800" cy="17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>
            <a:off x="3393000" y="48769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"/>
          <p:cNvSpPr/>
          <p:nvPr/>
        </p:nvSpPr>
        <p:spPr>
          <a:xfrm flipH="1">
            <a:off x="3139560" y="4757760"/>
            <a:ext cx="2588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"/>
          <p:cNvSpPr/>
          <p:nvPr/>
        </p:nvSpPr>
        <p:spPr>
          <a:xfrm>
            <a:off x="3398760" y="4532400"/>
            <a:ext cx="1800" cy="449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>
            <a:off x="3272040" y="46418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"/>
          <p:cNvSpPr/>
          <p:nvPr/>
        </p:nvSpPr>
        <p:spPr>
          <a:xfrm flipH="1">
            <a:off x="3714480" y="5243400"/>
            <a:ext cx="3841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"/>
          <p:cNvSpPr/>
          <p:nvPr/>
        </p:nvSpPr>
        <p:spPr>
          <a:xfrm>
            <a:off x="4147920" y="5180040"/>
            <a:ext cx="698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an. albican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"/>
          <p:cNvSpPr/>
          <p:nvPr/>
        </p:nvSpPr>
        <p:spPr>
          <a:xfrm flipH="1">
            <a:off x="3714480" y="5415120"/>
            <a:ext cx="1825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"/>
          <p:cNvSpPr/>
          <p:nvPr/>
        </p:nvSpPr>
        <p:spPr>
          <a:xfrm>
            <a:off x="3947040" y="5351400"/>
            <a:ext cx="1171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Debaromyces hansenii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"/>
          <p:cNvSpPr/>
          <p:nvPr/>
        </p:nvSpPr>
        <p:spPr>
          <a:xfrm flipH="1">
            <a:off x="3647880" y="532908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"/>
          <p:cNvSpPr/>
          <p:nvPr/>
        </p:nvSpPr>
        <p:spPr>
          <a:xfrm>
            <a:off x="3714840" y="5243400"/>
            <a:ext cx="1440" cy="171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"/>
          <p:cNvSpPr/>
          <p:nvPr/>
        </p:nvSpPr>
        <p:spPr>
          <a:xfrm>
            <a:off x="3581640" y="52117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"/>
          <p:cNvSpPr/>
          <p:nvPr/>
        </p:nvSpPr>
        <p:spPr>
          <a:xfrm flipH="1">
            <a:off x="3647880" y="5591160"/>
            <a:ext cx="2934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"/>
          <p:cNvSpPr/>
          <p:nvPr/>
        </p:nvSpPr>
        <p:spPr>
          <a:xfrm>
            <a:off x="3992040" y="5527800"/>
            <a:ext cx="947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an. guilliermondii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"/>
          <p:cNvSpPr/>
          <p:nvPr/>
        </p:nvSpPr>
        <p:spPr>
          <a:xfrm flipH="1">
            <a:off x="3558960" y="5462640"/>
            <a:ext cx="88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"/>
          <p:cNvSpPr/>
          <p:nvPr/>
        </p:nvSpPr>
        <p:spPr>
          <a:xfrm>
            <a:off x="3648240" y="5329080"/>
            <a:ext cx="1440" cy="262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"/>
          <p:cNvSpPr/>
          <p:nvPr/>
        </p:nvSpPr>
        <p:spPr>
          <a:xfrm>
            <a:off x="3515040" y="53481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"/>
          <p:cNvSpPr/>
          <p:nvPr/>
        </p:nvSpPr>
        <p:spPr>
          <a:xfrm flipH="1">
            <a:off x="3558960" y="5762520"/>
            <a:ext cx="2934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"/>
          <p:cNvSpPr/>
          <p:nvPr/>
        </p:nvSpPr>
        <p:spPr>
          <a:xfrm>
            <a:off x="3908160" y="5699160"/>
            <a:ext cx="7628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an. lusitania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"/>
          <p:cNvSpPr/>
          <p:nvPr/>
        </p:nvSpPr>
        <p:spPr>
          <a:xfrm flipH="1">
            <a:off x="3139560" y="5613480"/>
            <a:ext cx="4194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"/>
          <p:cNvSpPr/>
          <p:nvPr/>
        </p:nvSpPr>
        <p:spPr>
          <a:xfrm>
            <a:off x="3559320" y="5462640"/>
            <a:ext cx="1440" cy="299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"/>
          <p:cNvSpPr/>
          <p:nvPr/>
        </p:nvSpPr>
        <p:spPr>
          <a:xfrm>
            <a:off x="3353400" y="549576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"/>
          <p:cNvSpPr/>
          <p:nvPr/>
        </p:nvSpPr>
        <p:spPr>
          <a:xfrm flipH="1">
            <a:off x="2967120" y="5184720"/>
            <a:ext cx="1728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"/>
          <p:cNvSpPr/>
          <p:nvPr/>
        </p:nvSpPr>
        <p:spPr>
          <a:xfrm>
            <a:off x="3139920" y="4757760"/>
            <a:ext cx="1800" cy="855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"/>
          <p:cNvSpPr/>
          <p:nvPr/>
        </p:nvSpPr>
        <p:spPr>
          <a:xfrm>
            <a:off x="3015000" y="50673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"/>
          <p:cNvSpPr/>
          <p:nvPr/>
        </p:nvSpPr>
        <p:spPr>
          <a:xfrm flipH="1">
            <a:off x="2966760" y="5938920"/>
            <a:ext cx="453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"/>
          <p:cNvSpPr/>
          <p:nvPr/>
        </p:nvSpPr>
        <p:spPr>
          <a:xfrm>
            <a:off x="3474360" y="5875200"/>
            <a:ext cx="928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Yarrowia lipolytica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"/>
          <p:cNvSpPr/>
          <p:nvPr/>
        </p:nvSpPr>
        <p:spPr>
          <a:xfrm flipH="1">
            <a:off x="2841120" y="5559480"/>
            <a:ext cx="1256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"/>
          <p:cNvSpPr/>
          <p:nvPr/>
        </p:nvSpPr>
        <p:spPr>
          <a:xfrm>
            <a:off x="2967120" y="5184720"/>
            <a:ext cx="1440" cy="754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"/>
          <p:cNvSpPr/>
          <p:nvPr/>
        </p:nvSpPr>
        <p:spPr>
          <a:xfrm>
            <a:off x="2848320" y="54435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8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"/>
          <p:cNvSpPr/>
          <p:nvPr/>
        </p:nvSpPr>
        <p:spPr>
          <a:xfrm>
            <a:off x="2841480" y="4116240"/>
            <a:ext cx="18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"/>
          <p:cNvSpPr/>
          <p:nvPr/>
        </p:nvSpPr>
        <p:spPr>
          <a:xfrm>
            <a:off x="2841480" y="2673360"/>
            <a:ext cx="1800" cy="2886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"/>
          <p:cNvSpPr/>
          <p:nvPr/>
        </p:nvSpPr>
        <p:spPr>
          <a:xfrm flipH="1">
            <a:off x="2841480" y="6110280"/>
            <a:ext cx="540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"/>
          <p:cNvSpPr/>
          <p:nvPr/>
        </p:nvSpPr>
        <p:spPr>
          <a:xfrm>
            <a:off x="3428640" y="6045120"/>
            <a:ext cx="1210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aenorhabditis elegan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"/>
          <p:cNvSpPr/>
          <p:nvPr/>
        </p:nvSpPr>
        <p:spPr>
          <a:xfrm>
            <a:off x="2841480" y="4116240"/>
            <a:ext cx="1800" cy="1994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29T16:00:57Z</dcterms:created>
  <dc:creator> </dc:creator>
  <dc:description/>
  <dc:language>en-US</dc:language>
  <cp:lastModifiedBy>eek</cp:lastModifiedBy>
  <dcterms:modified xsi:type="dcterms:W3CDTF">2007-02-01T14:54:12Z</dcterms:modified>
  <cp:revision>4</cp:revision>
  <dc:subject/>
  <dc:title>PowerPoint Presentation</dc:title>
</cp:coreProperties>
</file>